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6" r:id="rId2"/>
    <p:sldId id="267" r:id="rId3"/>
    <p:sldId id="269" r:id="rId4"/>
  </p:sldIdLst>
  <p:sldSz cx="9144000" cy="6858000" type="screen4x3"/>
  <p:notesSz cx="6858000" cy="9144000"/>
  <p:defaultTextStyle>
    <a:defPPr>
      <a:defRPr lang="ko-KR"/>
    </a:defPPr>
    <a:lvl1pPr marL="0" algn="l" defTabSz="91427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39" algn="l" defTabSz="91427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79" algn="l" defTabSz="91427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18" algn="l" defTabSz="91427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58" algn="l" defTabSz="91427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698" algn="l" defTabSz="91427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37" algn="l" defTabSz="91427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976" algn="l" defTabSz="91427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115" algn="l" defTabSz="914279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08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2172">
          <p15:clr>
            <a:srgbClr val="A4A3A4"/>
          </p15:clr>
        </p15:guide>
        <p15:guide id="4" orient="horz" pos="2174">
          <p15:clr>
            <a:srgbClr val="A4A3A4"/>
          </p15:clr>
        </p15:guide>
        <p15:guide id="5" orient="horz" pos="216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198" autoAdjust="0"/>
  </p:normalViewPr>
  <p:slideViewPr>
    <p:cSldViewPr snapToGrid="0" showGuides="1">
      <p:cViewPr varScale="1">
        <p:scale>
          <a:sx n="82" d="100"/>
          <a:sy n="82" d="100"/>
        </p:scale>
        <p:origin x="1474" y="72"/>
      </p:cViewPr>
      <p:guideLst>
        <p:guide orient="horz" pos="2108"/>
        <p:guide pos="2880"/>
        <p:guide orient="horz" pos="2172"/>
        <p:guide orient="horz" pos="2174"/>
        <p:guide orient="horz" pos="216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66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ili\Desktop\&#49437;&#49324;%20&#51320;&#50629;&#45436;&#47928;%20&#45936;&#51060;&#53552;\&#44264;&#49604;&#48372;%20mtt\&#52628;&#52636;&#47932;%20&#48516;&#54925;&#52789;%20MTT\&#44264;&#49604;&#48372;%20&#52628;&#52636;&#47932;,%20&#48516;&#54925;&#52789;%20MTT%20&#52649;&#54788;%20&#49688;&#51221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ili\Desktop\&#51060;&#52649;&#54788;%20&#49892;&#54744;\&#44264;&#49604;&#48372;(&#45321;&#51460;&#44256;&#49324;&#47532;)\&#49437;&#49324;%20&#51320;&#50629;&#45436;&#47928;%20&#45936;&#51060;&#53552;\&#44264;&#49604;&#48372;%20mtt\&#52628;&#52636;&#47932;%20&#48516;&#54925;&#52789;%20MTT\20210908%20&#44264;&#49604;&#48372;%20&#52628;&#52636;&#47932;%20&#48516;&#54925;&#52789;%20MTT\20210908%20&#44264;&#49604;&#48372;%20&#52628;&#52636;&#47932;%20&#48516;&#54925;&#52789;%20MTT-&#52649;&#54788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ili\Desktop\&#45436;&#47928;,%20&#53945;&#54728;%20&#48143;%20&#48156;&#54364;%20&#51088;&#47308;\&#45321;&#51460;&#44256;&#49324;&#47532;%20&#45436;&#47928;%20&#51088;&#47308;\raw%20data\&#52649;&#54788;%20&#45800;&#51068;&#47932;&#51656;%204&#51333;%20MTT%20assa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0398-4C3D-AF58-B7EFEC4C8C95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B$49:$F$49</c:f>
                <c:numCache>
                  <c:formatCode>General</c:formatCode>
                  <c:ptCount val="5"/>
                  <c:pt idx="0">
                    <c:v>7.1054273576010019E-15</c:v>
                  </c:pt>
                  <c:pt idx="1">
                    <c:v>8.6222789477415329</c:v>
                  </c:pt>
                  <c:pt idx="2">
                    <c:v>7.6964915425722351</c:v>
                  </c:pt>
                  <c:pt idx="3">
                    <c:v>1.7787500329156087</c:v>
                  </c:pt>
                  <c:pt idx="4">
                    <c:v>3.7704822873196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Sheet1!$B$42:$F$42</c:f>
              <c:strCache>
                <c:ptCount val="5"/>
                <c:pt idx="0">
                  <c:v>CTR</c:v>
                </c:pt>
                <c:pt idx="1">
                  <c:v>100</c:v>
                </c:pt>
                <c:pt idx="2">
                  <c:v>50</c:v>
                </c:pt>
                <c:pt idx="3">
                  <c:v>25</c:v>
                </c:pt>
                <c:pt idx="4">
                  <c:v>12.5</c:v>
                </c:pt>
              </c:strCache>
            </c:strRef>
          </c:cat>
          <c:val>
            <c:numRef>
              <c:f>Sheet1!$B$47:$F$47</c:f>
              <c:numCache>
                <c:formatCode>General</c:formatCode>
                <c:ptCount val="5"/>
                <c:pt idx="0">
                  <c:v>100</c:v>
                </c:pt>
                <c:pt idx="1">
                  <c:v>82.819258313833927</c:v>
                </c:pt>
                <c:pt idx="2">
                  <c:v>83.93348569780018</c:v>
                </c:pt>
                <c:pt idx="3">
                  <c:v>87.186747492798148</c:v>
                </c:pt>
                <c:pt idx="4">
                  <c:v>89.3255148307610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398-4C3D-AF58-B7EFEC4C8C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41737088"/>
        <c:axId val="241894528"/>
      </c:barChart>
      <c:catAx>
        <c:axId val="24173708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 b="0"/>
            </a:pPr>
            <a:endParaRPr lang="en-US"/>
          </a:p>
        </c:txPr>
        <c:crossAx val="241894528"/>
        <c:crosses val="autoZero"/>
        <c:auto val="1"/>
        <c:lblAlgn val="ctr"/>
        <c:lblOffset val="100"/>
        <c:noMultiLvlLbl val="0"/>
      </c:catAx>
      <c:valAx>
        <c:axId val="24189452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Cell viability (% of Control)</a:t>
                </a:r>
                <a:endParaRPr lang="ko-KR" sz="140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2417370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A1C-4308-AE32-C0268FB3F492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B$24:$R$24</c:f>
                <c:numCache>
                  <c:formatCode>General</c:formatCode>
                  <c:ptCount val="17"/>
                  <c:pt idx="0">
                    <c:v>1.2189592021321591</c:v>
                  </c:pt>
                  <c:pt idx="1">
                    <c:v>7.2570974211286741</c:v>
                  </c:pt>
                  <c:pt idx="2">
                    <c:v>6.6270363832796413</c:v>
                  </c:pt>
                  <c:pt idx="3">
                    <c:v>6.0178818974500743</c:v>
                  </c:pt>
                  <c:pt idx="4">
                    <c:v>7.3707973389177619</c:v>
                  </c:pt>
                  <c:pt idx="5">
                    <c:v>3.6959369044865205</c:v>
                  </c:pt>
                  <c:pt idx="6">
                    <c:v>4.3611487711830534</c:v>
                  </c:pt>
                  <c:pt idx="7">
                    <c:v>2.7398118494102679</c:v>
                  </c:pt>
                  <c:pt idx="8">
                    <c:v>3.8492622065349966</c:v>
                  </c:pt>
                  <c:pt idx="9">
                    <c:v>1.0218622438379872</c:v>
                  </c:pt>
                  <c:pt idx="10">
                    <c:v>4.4861224376617805</c:v>
                  </c:pt>
                  <c:pt idx="11">
                    <c:v>3.5940385122658896</c:v>
                  </c:pt>
                  <c:pt idx="12">
                    <c:v>6.9017416427716665</c:v>
                  </c:pt>
                  <c:pt idx="13">
                    <c:v>1.4508045370614651</c:v>
                  </c:pt>
                  <c:pt idx="14">
                    <c:v>1.5759073871916554</c:v>
                  </c:pt>
                  <c:pt idx="15">
                    <c:v>4.39497145764377</c:v>
                  </c:pt>
                  <c:pt idx="16">
                    <c:v>6.70670694269695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1:$U$2</c:f>
              <c:strCache>
                <c:ptCount val="21"/>
                <c:pt idx="0">
                  <c:v>CTR</c:v>
                </c:pt>
                <c:pt idx="1">
                  <c:v>100</c:v>
                </c:pt>
                <c:pt idx="2">
                  <c:v>50</c:v>
                </c:pt>
                <c:pt idx="3">
                  <c:v>25</c:v>
                </c:pt>
                <c:pt idx="4">
                  <c:v>12.5</c:v>
                </c:pt>
                <c:pt idx="5">
                  <c:v>100</c:v>
                </c:pt>
                <c:pt idx="6">
                  <c:v>50</c:v>
                </c:pt>
                <c:pt idx="7">
                  <c:v>25</c:v>
                </c:pt>
                <c:pt idx="8">
                  <c:v>12.5</c:v>
                </c:pt>
                <c:pt idx="9">
                  <c:v>100</c:v>
                </c:pt>
                <c:pt idx="10">
                  <c:v>50</c:v>
                </c:pt>
                <c:pt idx="11">
                  <c:v>25</c:v>
                </c:pt>
                <c:pt idx="12">
                  <c:v>12.5</c:v>
                </c:pt>
                <c:pt idx="13">
                  <c:v>100</c:v>
                </c:pt>
                <c:pt idx="14">
                  <c:v>50</c:v>
                </c:pt>
                <c:pt idx="15">
                  <c:v>25</c:v>
                </c:pt>
                <c:pt idx="16">
                  <c:v>12.5</c:v>
                </c:pt>
                <c:pt idx="17">
                  <c:v>100</c:v>
                </c:pt>
                <c:pt idx="18">
                  <c:v>50</c:v>
                </c:pt>
                <c:pt idx="19">
                  <c:v>25</c:v>
                </c:pt>
                <c:pt idx="20">
                  <c:v>12.5</c:v>
                </c:pt>
              </c:strCache>
            </c:strRef>
          </c:cat>
          <c:val>
            <c:numRef>
              <c:f>Sheet1!$B$22:$R$22</c:f>
              <c:numCache>
                <c:formatCode>General</c:formatCode>
                <c:ptCount val="17"/>
                <c:pt idx="0">
                  <c:v>99.999999999999986</c:v>
                </c:pt>
                <c:pt idx="1">
                  <c:v>120.31580916576098</c:v>
                </c:pt>
                <c:pt idx="2">
                  <c:v>126.77282582477424</c:v>
                </c:pt>
                <c:pt idx="3">
                  <c:v>119.47026833961262</c:v>
                </c:pt>
                <c:pt idx="4">
                  <c:v>115.6456401276171</c:v>
                </c:pt>
                <c:pt idx="5">
                  <c:v>43.212449783717027</c:v>
                </c:pt>
                <c:pt idx="6">
                  <c:v>91.388038220271909</c:v>
                </c:pt>
                <c:pt idx="7">
                  <c:v>100.00833062448152</c:v>
                </c:pt>
                <c:pt idx="8">
                  <c:v>113.47451320959931</c:v>
                </c:pt>
                <c:pt idx="9">
                  <c:v>86.696562032884913</c:v>
                </c:pt>
                <c:pt idx="10">
                  <c:v>82.519016476617296</c:v>
                </c:pt>
                <c:pt idx="11">
                  <c:v>83.915853336850432</c:v>
                </c:pt>
                <c:pt idx="12">
                  <c:v>89.670210709124845</c:v>
                </c:pt>
                <c:pt idx="13">
                  <c:v>80.123977842257972</c:v>
                </c:pt>
                <c:pt idx="14">
                  <c:v>80.262657635229885</c:v>
                </c:pt>
                <c:pt idx="15">
                  <c:v>82.20513971672834</c:v>
                </c:pt>
                <c:pt idx="16">
                  <c:v>85.6999918180913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A1C-4308-AE32-C0268FB3F4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00257664"/>
        <c:axId val="300259200"/>
      </c:barChart>
      <c:catAx>
        <c:axId val="30025766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00259200"/>
        <c:crosses val="autoZero"/>
        <c:auto val="1"/>
        <c:lblAlgn val="ctr"/>
        <c:lblOffset val="100"/>
        <c:noMultiLvlLbl val="0"/>
      </c:catAx>
      <c:valAx>
        <c:axId val="30025920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Cell viability (% of Control)</a:t>
                </a:r>
                <a:endParaRPr lang="ko-KR" sz="140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002576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ln w="12700"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F8DE-4C3E-90C1-B5FE5B667065}"/>
              </c:ext>
            </c:extLst>
          </c:dPt>
          <c:errBars>
            <c:errBarType val="plus"/>
            <c:errValType val="cust"/>
            <c:noEndCap val="0"/>
            <c:plus>
              <c:numRef>
                <c:f>'1세트 5개'!$C$75:$K$75</c:f>
                <c:numCache>
                  <c:formatCode>General</c:formatCode>
                  <c:ptCount val="9"/>
                  <c:pt idx="0">
                    <c:v>5.3195818087299678</c:v>
                  </c:pt>
                  <c:pt idx="1">
                    <c:v>5.3541180946929545</c:v>
                  </c:pt>
                  <c:pt idx="2">
                    <c:v>1.8581584411731824</c:v>
                  </c:pt>
                  <c:pt idx="3">
                    <c:v>2.609398914262159</c:v>
                  </c:pt>
                  <c:pt idx="4">
                    <c:v>3.0647723349332772</c:v>
                  </c:pt>
                  <c:pt idx="5">
                    <c:v>1.6360221371908572</c:v>
                  </c:pt>
                  <c:pt idx="6">
                    <c:v>1.6723249872801087</c:v>
                  </c:pt>
                  <c:pt idx="7">
                    <c:v>1.3612527007928819</c:v>
                  </c:pt>
                  <c:pt idx="8">
                    <c:v>1.38067880365645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>
                <a:solidFill>
                  <a:schemeClr val="tx1"/>
                </a:solidFill>
              </a:ln>
            </c:spPr>
          </c:errBars>
          <c:cat>
            <c:strRef>
              <c:f>'1세트 5개'!$C$68:$K$68</c:f>
              <c:strCache>
                <c:ptCount val="9"/>
                <c:pt idx="0">
                  <c:v>CTR</c:v>
                </c:pt>
                <c:pt idx="1">
                  <c:v>50</c:v>
                </c:pt>
                <c:pt idx="2">
                  <c:v>10</c:v>
                </c:pt>
                <c:pt idx="3">
                  <c:v>50</c:v>
                </c:pt>
                <c:pt idx="4">
                  <c:v>10</c:v>
                </c:pt>
                <c:pt idx="5">
                  <c:v>50</c:v>
                </c:pt>
                <c:pt idx="6">
                  <c:v>10</c:v>
                </c:pt>
                <c:pt idx="7">
                  <c:v>50</c:v>
                </c:pt>
                <c:pt idx="8">
                  <c:v>10</c:v>
                </c:pt>
              </c:strCache>
            </c:strRef>
          </c:cat>
          <c:val>
            <c:numRef>
              <c:f>'1세트 5개'!$C$73:$K$73</c:f>
              <c:numCache>
                <c:formatCode>General</c:formatCode>
                <c:ptCount val="9"/>
                <c:pt idx="0">
                  <c:v>100</c:v>
                </c:pt>
                <c:pt idx="1">
                  <c:v>83.037285965754521</c:v>
                </c:pt>
                <c:pt idx="2">
                  <c:v>86.925908145303239</c:v>
                </c:pt>
                <c:pt idx="3">
                  <c:v>87.80604896783484</c:v>
                </c:pt>
                <c:pt idx="4">
                  <c:v>91.054568730996948</c:v>
                </c:pt>
                <c:pt idx="5">
                  <c:v>101.00816130580893</c:v>
                </c:pt>
                <c:pt idx="6">
                  <c:v>91.486637862057933</c:v>
                </c:pt>
                <c:pt idx="7">
                  <c:v>87.27796447431588</c:v>
                </c:pt>
                <c:pt idx="8">
                  <c:v>87.6300208033285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8DE-4C3E-90C1-B5FE5B6670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17635200"/>
        <c:axId val="318259584"/>
      </c:barChart>
      <c:catAx>
        <c:axId val="31763520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18259584"/>
        <c:crosses val="autoZero"/>
        <c:auto val="1"/>
        <c:lblAlgn val="ctr"/>
        <c:lblOffset val="100"/>
        <c:noMultiLvlLbl val="0"/>
      </c:catAx>
      <c:valAx>
        <c:axId val="31825958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Cell viability (% of Control)</a:t>
                </a:r>
                <a:endParaRPr lang="ko-KR" sz="140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17635200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3A2304-DB9A-4B24-A55A-C07B20DFAD2D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D0E185-7EFD-4E2F-BF8D-DC8089B4305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1689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79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39" algn="l" defTabSz="914279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79" algn="l" defTabSz="914279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18" algn="l" defTabSz="914279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58" algn="l" defTabSz="914279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98" algn="l" defTabSz="914279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37" algn="l" defTabSz="914279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976" algn="l" defTabSz="914279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115" algn="l" defTabSz="914279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4DD194-95CC-4399-99F2-7D9A918D19CF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26293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4DD194-95CC-4399-99F2-7D9A918D19CF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262931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34DD194-95CC-4399-99F2-7D9A918D19CF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26293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1" y="2130426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6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9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2272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2423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4843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7500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3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7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1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69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3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97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1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1946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2024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9" indent="0">
              <a:buNone/>
              <a:defRPr sz="2000" b="1"/>
            </a:lvl2pPr>
            <a:lvl3pPr marL="914279" indent="0">
              <a:buNone/>
              <a:defRPr sz="1800" b="1"/>
            </a:lvl3pPr>
            <a:lvl4pPr marL="1371418" indent="0">
              <a:buNone/>
              <a:defRPr sz="1600" b="1"/>
            </a:lvl4pPr>
            <a:lvl5pPr marL="1828558" indent="0">
              <a:buNone/>
              <a:defRPr sz="1600" b="1"/>
            </a:lvl5pPr>
            <a:lvl6pPr marL="2285698" indent="0">
              <a:buNone/>
              <a:defRPr sz="1600" b="1"/>
            </a:lvl6pPr>
            <a:lvl7pPr marL="2742837" indent="0">
              <a:buNone/>
              <a:defRPr sz="1600" b="1"/>
            </a:lvl7pPr>
            <a:lvl8pPr marL="3199976" indent="0">
              <a:buNone/>
              <a:defRPr sz="1600" b="1"/>
            </a:lvl8pPr>
            <a:lvl9pPr marL="3657115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39" indent="0">
              <a:buNone/>
              <a:defRPr sz="2000" b="1"/>
            </a:lvl2pPr>
            <a:lvl3pPr marL="914279" indent="0">
              <a:buNone/>
              <a:defRPr sz="1800" b="1"/>
            </a:lvl3pPr>
            <a:lvl4pPr marL="1371418" indent="0">
              <a:buNone/>
              <a:defRPr sz="1600" b="1"/>
            </a:lvl4pPr>
            <a:lvl5pPr marL="1828558" indent="0">
              <a:buNone/>
              <a:defRPr sz="1600" b="1"/>
            </a:lvl5pPr>
            <a:lvl6pPr marL="2285698" indent="0">
              <a:buNone/>
              <a:defRPr sz="1600" b="1"/>
            </a:lvl6pPr>
            <a:lvl7pPr marL="2742837" indent="0">
              <a:buNone/>
              <a:defRPr sz="1600" b="1"/>
            </a:lvl7pPr>
            <a:lvl8pPr marL="3199976" indent="0">
              <a:buNone/>
              <a:defRPr sz="1600" b="1"/>
            </a:lvl8pPr>
            <a:lvl9pPr marL="3657115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30486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45177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7457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2" y="273051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2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39" indent="0">
              <a:buNone/>
              <a:defRPr sz="1200"/>
            </a:lvl2pPr>
            <a:lvl3pPr marL="914279" indent="0">
              <a:buNone/>
              <a:defRPr sz="1000"/>
            </a:lvl3pPr>
            <a:lvl4pPr marL="1371418" indent="0">
              <a:buNone/>
              <a:defRPr sz="900"/>
            </a:lvl4pPr>
            <a:lvl5pPr marL="1828558" indent="0">
              <a:buNone/>
              <a:defRPr sz="900"/>
            </a:lvl5pPr>
            <a:lvl6pPr marL="2285698" indent="0">
              <a:buNone/>
              <a:defRPr sz="900"/>
            </a:lvl6pPr>
            <a:lvl7pPr marL="2742837" indent="0">
              <a:buNone/>
              <a:defRPr sz="900"/>
            </a:lvl7pPr>
            <a:lvl8pPr marL="3199976" indent="0">
              <a:buNone/>
              <a:defRPr sz="900"/>
            </a:lvl8pPr>
            <a:lvl9pPr marL="3657115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9036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39" indent="0">
              <a:buNone/>
              <a:defRPr sz="2800"/>
            </a:lvl2pPr>
            <a:lvl3pPr marL="914279" indent="0">
              <a:buNone/>
              <a:defRPr sz="2400"/>
            </a:lvl3pPr>
            <a:lvl4pPr marL="1371418" indent="0">
              <a:buNone/>
              <a:defRPr sz="2000"/>
            </a:lvl4pPr>
            <a:lvl5pPr marL="1828558" indent="0">
              <a:buNone/>
              <a:defRPr sz="2000"/>
            </a:lvl5pPr>
            <a:lvl6pPr marL="2285698" indent="0">
              <a:buNone/>
              <a:defRPr sz="2000"/>
            </a:lvl6pPr>
            <a:lvl7pPr marL="2742837" indent="0">
              <a:buNone/>
              <a:defRPr sz="2000"/>
            </a:lvl7pPr>
            <a:lvl8pPr marL="3199976" indent="0">
              <a:buNone/>
              <a:defRPr sz="2000"/>
            </a:lvl8pPr>
            <a:lvl9pPr marL="3657115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39" indent="0">
              <a:buNone/>
              <a:defRPr sz="1200"/>
            </a:lvl2pPr>
            <a:lvl3pPr marL="914279" indent="0">
              <a:buNone/>
              <a:defRPr sz="1000"/>
            </a:lvl3pPr>
            <a:lvl4pPr marL="1371418" indent="0">
              <a:buNone/>
              <a:defRPr sz="900"/>
            </a:lvl4pPr>
            <a:lvl5pPr marL="1828558" indent="0">
              <a:buNone/>
              <a:defRPr sz="900"/>
            </a:lvl5pPr>
            <a:lvl6pPr marL="2285698" indent="0">
              <a:buNone/>
              <a:defRPr sz="900"/>
            </a:lvl6pPr>
            <a:lvl7pPr marL="2742837" indent="0">
              <a:buNone/>
              <a:defRPr sz="900"/>
            </a:lvl7pPr>
            <a:lvl8pPr marL="3199976" indent="0">
              <a:buNone/>
              <a:defRPr sz="900"/>
            </a:lvl8pPr>
            <a:lvl9pPr marL="3657115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6582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1" y="274638"/>
            <a:ext cx="8229600" cy="1143000"/>
          </a:xfrm>
          <a:prstGeom prst="rect">
            <a:avLst/>
          </a:prstGeom>
        </p:spPr>
        <p:txBody>
          <a:bodyPr vert="horz" lIns="91428" tIns="45715" rIns="91428" bIns="45715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1" y="1600202"/>
            <a:ext cx="8229600" cy="4525963"/>
          </a:xfrm>
          <a:prstGeom prst="rect">
            <a:avLst/>
          </a:prstGeom>
        </p:spPr>
        <p:txBody>
          <a:bodyPr vert="horz" lIns="91428" tIns="45715" rIns="91428" bIns="45715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28" tIns="45715" rIns="91428" bIns="45715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DF272E-7391-48C0-B97A-98D54185B8F8}" type="datetimeFigureOut">
              <a:rPr lang="ko-KR" altLang="en-US" smtClean="0"/>
              <a:t>2023-1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1" y="6356352"/>
            <a:ext cx="2895600" cy="365125"/>
          </a:xfrm>
          <a:prstGeom prst="rect">
            <a:avLst/>
          </a:prstGeom>
        </p:spPr>
        <p:txBody>
          <a:bodyPr vert="horz" lIns="91428" tIns="45715" rIns="91428" bIns="45715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1" y="6356352"/>
            <a:ext cx="2133600" cy="365125"/>
          </a:xfrm>
          <a:prstGeom prst="rect">
            <a:avLst/>
          </a:prstGeom>
        </p:spPr>
        <p:txBody>
          <a:bodyPr vert="horz" lIns="91428" tIns="45715" rIns="91428" bIns="45715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E0A35E-0ACA-4CD8-9283-A8FDE12007F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0600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79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5" indent="-342855" algn="l" defTabSz="914279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52" indent="-285712" algn="l" defTabSz="914279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49" indent="-228570" algn="l" defTabSz="914279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988" indent="-228570" algn="l" defTabSz="914279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27" indent="-228570" algn="l" defTabSz="914279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267" indent="-228570" algn="l" defTabSz="914279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06" indent="-228570" algn="l" defTabSz="914279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46" indent="-228570" algn="l" defTabSz="914279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686" indent="-228570" algn="l" defTabSz="914279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27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39" algn="l" defTabSz="91427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79" algn="l" defTabSz="91427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18" algn="l" defTabSz="91427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58" algn="l" defTabSz="91427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698" algn="l" defTabSz="91427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37" algn="l" defTabSz="91427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976" algn="l" defTabSz="91427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15" algn="l" defTabSz="914279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차트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1352179"/>
              </p:ext>
            </p:extLst>
          </p:nvPr>
        </p:nvGraphicFramePr>
        <p:xfrm>
          <a:off x="1483537" y="1154188"/>
          <a:ext cx="432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0F1ABBBA-FA99-4169-90BF-F034780E1C40}"/>
              </a:ext>
            </a:extLst>
          </p:cNvPr>
          <p:cNvSpPr txBox="1"/>
          <p:nvPr/>
        </p:nvSpPr>
        <p:spPr>
          <a:xfrm>
            <a:off x="0" y="411"/>
            <a:ext cx="8534400" cy="338544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fontAlgn="base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Effect of DME on the viability of APP-CHO cells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EF4FC79-F117-4470-860C-074D6E1C949B}"/>
              </a:ext>
            </a:extLst>
          </p:cNvPr>
          <p:cNvSpPr txBox="1"/>
          <p:nvPr/>
        </p:nvSpPr>
        <p:spPr>
          <a:xfrm>
            <a:off x="5500465" y="3692923"/>
            <a:ext cx="864096" cy="276989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직선 연결선 33"/>
          <p:cNvCxnSpPr/>
          <p:nvPr/>
        </p:nvCxnSpPr>
        <p:spPr>
          <a:xfrm>
            <a:off x="3059833" y="4016097"/>
            <a:ext cx="23042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3059833" y="4016098"/>
            <a:ext cx="2304256" cy="307766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E</a:t>
            </a:r>
            <a:endParaRPr lang="ko-KR" altLang="en-US" sz="14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3F96DA6A-94C0-45E4-86A9-D76EF57858D8}"/>
              </a:ext>
            </a:extLst>
          </p:cNvPr>
          <p:cNvCxnSpPr>
            <a:cxnSpLocks/>
          </p:cNvCxnSpPr>
          <p:nvPr/>
        </p:nvCxnSpPr>
        <p:spPr>
          <a:xfrm>
            <a:off x="2165005" y="2089061"/>
            <a:ext cx="3415109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69569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0" name="차트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7012652"/>
              </p:ext>
            </p:extLst>
          </p:nvPr>
        </p:nvGraphicFramePr>
        <p:xfrm>
          <a:off x="944886" y="669302"/>
          <a:ext cx="6480000" cy="28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0F1ABBBA-FA99-4169-90BF-F034780E1C40}"/>
              </a:ext>
            </a:extLst>
          </p:cNvPr>
          <p:cNvSpPr txBox="1"/>
          <p:nvPr/>
        </p:nvSpPr>
        <p:spPr>
          <a:xfrm>
            <a:off x="0" y="411"/>
            <a:ext cx="9144000" cy="338544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fontAlgn="base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Cytotoxicity of the solvent-partitioned fractions of DM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102892" y="3553564"/>
            <a:ext cx="1188132" cy="323155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x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EF4FC79-F117-4470-860C-074D6E1C949B}"/>
              </a:ext>
            </a:extLst>
          </p:cNvPr>
          <p:cNvSpPr txBox="1"/>
          <p:nvPr/>
        </p:nvSpPr>
        <p:spPr>
          <a:xfrm>
            <a:off x="7236296" y="3229745"/>
            <a:ext cx="720080" cy="276989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2102892" y="3543300"/>
            <a:ext cx="11881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3419872" y="3553564"/>
            <a:ext cx="1188132" cy="323155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CM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직선 연결선 21"/>
          <p:cNvCxnSpPr/>
          <p:nvPr/>
        </p:nvCxnSpPr>
        <p:spPr>
          <a:xfrm>
            <a:off x="3419872" y="3543300"/>
            <a:ext cx="11881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716016" y="3553564"/>
            <a:ext cx="1188132" cy="323155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직선 연결선 23"/>
          <p:cNvCxnSpPr/>
          <p:nvPr/>
        </p:nvCxnSpPr>
        <p:spPr>
          <a:xfrm>
            <a:off x="4716016" y="3543300"/>
            <a:ext cx="11881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6048164" y="3553564"/>
            <a:ext cx="1188132" cy="323155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W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" name="직선 연결선 28"/>
          <p:cNvCxnSpPr/>
          <p:nvPr/>
        </p:nvCxnSpPr>
        <p:spPr>
          <a:xfrm>
            <a:off x="6048164" y="3543300"/>
            <a:ext cx="11881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3F96DA6A-94C0-45E4-86A9-D76EF57858D8}"/>
              </a:ext>
            </a:extLst>
          </p:cNvPr>
          <p:cNvCxnSpPr>
            <a:cxnSpLocks/>
          </p:cNvCxnSpPr>
          <p:nvPr/>
        </p:nvCxnSpPr>
        <p:spPr>
          <a:xfrm>
            <a:off x="1610068" y="2007377"/>
            <a:ext cx="5692292" cy="0"/>
          </a:xfrm>
          <a:prstGeom prst="line">
            <a:avLst/>
          </a:prstGeom>
          <a:ln w="127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3389025" y="2251704"/>
            <a:ext cx="236849" cy="246211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ko-KR" altLang="en-US" sz="1000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✱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703951" y="1640199"/>
            <a:ext cx="236849" cy="246211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ko-KR" altLang="en-US" sz="1000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✱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718742" y="1532085"/>
            <a:ext cx="236849" cy="246211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ko-KR" altLang="en-US" sz="1000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✱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406134" y="961844"/>
            <a:ext cx="236849" cy="246211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ko-KR" altLang="en-US" sz="1000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✱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030976" y="1675124"/>
            <a:ext cx="236849" cy="246211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ko-KR" altLang="en-US" sz="1000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✱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361970" y="1660282"/>
            <a:ext cx="236849" cy="246211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ko-KR" altLang="en-US" sz="1000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✱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019194" y="1721807"/>
            <a:ext cx="236849" cy="246211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ko-KR" altLang="en-US" sz="1000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✱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6345425" y="1717766"/>
            <a:ext cx="236849" cy="246211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ko-KR" altLang="en-US" sz="1000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✱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674038" y="1663002"/>
            <a:ext cx="236849" cy="246211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ko-KR" altLang="en-US" sz="1000" dirty="0"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✱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33C480D-EBE6-4825-92BF-9B0FE1C24FC7}"/>
              </a:ext>
            </a:extLst>
          </p:cNvPr>
          <p:cNvSpPr txBox="1"/>
          <p:nvPr/>
        </p:nvSpPr>
        <p:spPr>
          <a:xfrm>
            <a:off x="5477069" y="961844"/>
            <a:ext cx="13529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* </a:t>
            </a:r>
            <a:r>
              <a:rPr lang="en-US" sz="1100" i="1" dirty="0"/>
              <a:t>p</a:t>
            </a:r>
            <a:r>
              <a:rPr lang="en-US" sz="1100" dirty="0"/>
              <a:t> &lt; 0.05</a:t>
            </a:r>
          </a:p>
        </p:txBody>
      </p:sp>
    </p:spTree>
    <p:extLst>
      <p:ext uri="{BB962C8B-B14F-4D97-AF65-F5344CB8AC3E}">
        <p14:creationId xmlns:p14="http://schemas.microsoft.com/office/powerpoint/2010/main" val="29111955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차트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5230748"/>
              </p:ext>
            </p:extLst>
          </p:nvPr>
        </p:nvGraphicFramePr>
        <p:xfrm>
          <a:off x="1318878" y="1126117"/>
          <a:ext cx="6076282" cy="32720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0F1ABBBA-FA99-4169-90BF-F034780E1C40}"/>
              </a:ext>
            </a:extLst>
          </p:cNvPr>
          <p:cNvSpPr txBox="1"/>
          <p:nvPr/>
        </p:nvSpPr>
        <p:spPr>
          <a:xfrm>
            <a:off x="4478" y="2020"/>
            <a:ext cx="9139522" cy="338544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fontAlgn="base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Effect of compounds isolated from DME on the viability of APP-CHO cells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EF4FC79-F117-4470-860C-074D6E1C949B}"/>
              </a:ext>
            </a:extLst>
          </p:cNvPr>
          <p:cNvSpPr txBox="1"/>
          <p:nvPr/>
        </p:nvSpPr>
        <p:spPr>
          <a:xfrm>
            <a:off x="7177450" y="4083131"/>
            <a:ext cx="858837" cy="276989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856284" y="4398151"/>
            <a:ext cx="725860" cy="276989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3F96DA6A-94C0-45E4-86A9-D76EF57858D8}"/>
              </a:ext>
            </a:extLst>
          </p:cNvPr>
          <p:cNvCxnSpPr>
            <a:cxnSpLocks/>
          </p:cNvCxnSpPr>
          <p:nvPr/>
        </p:nvCxnSpPr>
        <p:spPr>
          <a:xfrm>
            <a:off x="1997968" y="2198450"/>
            <a:ext cx="5367982" cy="0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30"/>
          <p:cNvCxnSpPr/>
          <p:nvPr/>
        </p:nvCxnSpPr>
        <p:spPr>
          <a:xfrm>
            <a:off x="5166320" y="4398149"/>
            <a:ext cx="720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/>
          <p:cNvCxnSpPr/>
          <p:nvPr/>
        </p:nvCxnSpPr>
        <p:spPr>
          <a:xfrm>
            <a:off x="2862064" y="4398149"/>
            <a:ext cx="720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>
            <a:off x="4008412" y="4398149"/>
            <a:ext cx="720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/>
          <p:cNvCxnSpPr/>
          <p:nvPr/>
        </p:nvCxnSpPr>
        <p:spPr>
          <a:xfrm>
            <a:off x="6318448" y="4398149"/>
            <a:ext cx="72008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4008412" y="4398151"/>
            <a:ext cx="725860" cy="276989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5160540" y="4398151"/>
            <a:ext cx="725860" cy="276989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312668" y="4398151"/>
            <a:ext cx="725860" cy="276989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5" name="직선 연결선 54"/>
          <p:cNvCxnSpPr/>
          <p:nvPr/>
        </p:nvCxnSpPr>
        <p:spPr>
          <a:xfrm>
            <a:off x="2862065" y="4675148"/>
            <a:ext cx="417646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2856284" y="4668123"/>
            <a:ext cx="4182244" cy="338544"/>
          </a:xfrm>
          <a:prstGeom prst="rect">
            <a:avLst/>
          </a:prstGeom>
          <a:noFill/>
        </p:spPr>
        <p:txBody>
          <a:bodyPr wrap="square" lIns="91428" tIns="45715" rIns="91428" bIns="45715" rtlCol="0">
            <a:spAutoFit/>
          </a:bodyPr>
          <a:lstStyle/>
          <a:p>
            <a:pPr algn="ctr"/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unds</a:t>
            </a:r>
            <a:endParaRPr lang="el-GR" altLang="ko-KR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7474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43</TotalTime>
  <Words>95</Words>
  <Application>Microsoft Office PowerPoint</Application>
  <PresentationFormat>On-screen Show (4:3)</PresentationFormat>
  <Paragraphs>32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맑은 고딕</vt:lpstr>
      <vt:lpstr>함초롬바탕</vt:lpstr>
      <vt:lpstr>Arial</vt:lpstr>
      <vt:lpstr>Times New Roman</vt:lpstr>
      <vt:lpstr>Office 테마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ailious34@naver.com</dc:creator>
  <cp:lastModifiedBy>MDPI</cp:lastModifiedBy>
  <cp:revision>192</cp:revision>
  <dcterms:created xsi:type="dcterms:W3CDTF">2023-07-02T13:27:48Z</dcterms:created>
  <dcterms:modified xsi:type="dcterms:W3CDTF">2023-11-14T01:57:43Z</dcterms:modified>
</cp:coreProperties>
</file>